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26" r:id="rId2"/>
  </p:sldIdLst>
  <p:sldSz cx="6858000" cy="9144000" type="letter"/>
  <p:notesSz cx="6881813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9" pos="3960" userDrawn="1">
          <p15:clr>
            <a:srgbClr val="A4A3A4"/>
          </p15:clr>
        </p15:guide>
        <p15:guide id="20" pos="360" userDrawn="1">
          <p15:clr>
            <a:srgbClr val="A4A3A4"/>
          </p15:clr>
        </p15:guide>
        <p15:guide id="23" orient="horz" pos="5616" userDrawn="1">
          <p15:clr>
            <a:srgbClr val="A4A3A4"/>
          </p15:clr>
        </p15:guide>
        <p15:guide id="27" orient="horz" pos="168" userDrawn="1">
          <p15:clr>
            <a:srgbClr val="A4A3A4"/>
          </p15:clr>
        </p15:guide>
        <p15:guide id="30" pos="2208" userDrawn="1">
          <p15:clr>
            <a:srgbClr val="A4A3A4"/>
          </p15:clr>
        </p15:guide>
        <p15:guide id="31" orient="horz" pos="3480" userDrawn="1">
          <p15:clr>
            <a:srgbClr val="A4A3A4"/>
          </p15:clr>
        </p15:guide>
        <p15:guide id="32" orient="horz" pos="3572" userDrawn="1">
          <p15:clr>
            <a:srgbClr val="A4A3A4"/>
          </p15:clr>
        </p15:guide>
        <p15:guide id="34" pos="2352" userDrawn="1">
          <p15:clr>
            <a:srgbClr val="A4A3A4"/>
          </p15:clr>
        </p15:guide>
        <p15:guide id="35" orient="horz" pos="4992" userDrawn="1">
          <p15:clr>
            <a:srgbClr val="A4A3A4"/>
          </p15:clr>
        </p15:guide>
        <p15:guide id="36" pos="386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nikos" initials="n" lastIdx="0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  <a:srgbClr val="FF00FF"/>
    <a:srgbClr val="00CC66"/>
    <a:srgbClr val="69A4DD"/>
    <a:srgbClr val="00B853"/>
    <a:srgbClr val="00DA63"/>
    <a:srgbClr val="00CC00"/>
    <a:srgbClr val="0A15EC"/>
    <a:srgbClr val="070FB9"/>
    <a:srgbClr val="EDEDE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42" autoAdjust="0"/>
    <p:restoredTop sz="94799" autoAdjust="0"/>
  </p:normalViewPr>
  <p:slideViewPr>
    <p:cSldViewPr snapToGrid="0" snapToObjects="1" showGuides="1">
      <p:cViewPr varScale="1">
        <p:scale>
          <a:sx n="84" d="100"/>
          <a:sy n="84" d="100"/>
        </p:scale>
        <p:origin x="2598" y="84"/>
      </p:cViewPr>
      <p:guideLst>
        <p:guide pos="3960"/>
        <p:guide pos="360"/>
        <p:guide orient="horz" pos="5616"/>
        <p:guide orient="horz" pos="168"/>
        <p:guide pos="2208"/>
        <p:guide orient="horz" pos="3480"/>
        <p:guide orient="horz" pos="3572"/>
        <p:guide pos="2352"/>
        <p:guide orient="horz" pos="4992"/>
        <p:guide pos="386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colás cecchini" userId="2ee1d923c713d6a4" providerId="LiveId" clId="{BCE686E1-0297-4627-B61C-156CFF4CF7AE}"/>
    <pc:docChg chg="modSld">
      <pc:chgData name="nicolás cecchini" userId="2ee1d923c713d6a4" providerId="LiveId" clId="{BCE686E1-0297-4627-B61C-156CFF4CF7AE}" dt="2020-12-08T14:54:15.427" v="57" actId="164"/>
      <pc:docMkLst>
        <pc:docMk/>
      </pc:docMkLst>
      <pc:sldChg chg="addSp modSp mod">
        <pc:chgData name="nicolás cecchini" userId="2ee1d923c713d6a4" providerId="LiveId" clId="{BCE686E1-0297-4627-B61C-156CFF4CF7AE}" dt="2020-12-08T14:54:15.427" v="57" actId="164"/>
        <pc:sldMkLst>
          <pc:docMk/>
          <pc:sldMk cId="2721414211" sldId="326"/>
        </pc:sldMkLst>
        <pc:spChg chg="add mod">
          <ac:chgData name="nicolás cecchini" userId="2ee1d923c713d6a4" providerId="LiveId" clId="{BCE686E1-0297-4627-B61C-156CFF4CF7AE}" dt="2020-12-08T14:54:15.427" v="57" actId="164"/>
          <ac:spMkLst>
            <pc:docMk/>
            <pc:sldMk cId="2721414211" sldId="326"/>
            <ac:spMk id="4" creationId="{AC5331DE-02B4-4E76-A2F3-25221782BB4D}"/>
          </ac:spMkLst>
        </pc:spChg>
        <pc:spChg chg="add mod">
          <ac:chgData name="nicolás cecchini" userId="2ee1d923c713d6a4" providerId="LiveId" clId="{BCE686E1-0297-4627-B61C-156CFF4CF7AE}" dt="2020-12-08T14:54:15.427" v="57" actId="164"/>
          <ac:spMkLst>
            <pc:docMk/>
            <pc:sldMk cId="2721414211" sldId="326"/>
            <ac:spMk id="23" creationId="{ADE2E69D-D585-4286-AFF2-21926D147DAA}"/>
          </ac:spMkLst>
        </pc:spChg>
        <pc:spChg chg="add mod">
          <ac:chgData name="nicolás cecchini" userId="2ee1d923c713d6a4" providerId="LiveId" clId="{BCE686E1-0297-4627-B61C-156CFF4CF7AE}" dt="2020-12-08T14:54:15.427" v="57" actId="164"/>
          <ac:spMkLst>
            <pc:docMk/>
            <pc:sldMk cId="2721414211" sldId="326"/>
            <ac:spMk id="25" creationId="{D9DC7E0F-F466-4DA3-9B88-D4D30A9A37B7}"/>
          </ac:spMkLst>
        </pc:spChg>
        <pc:grpChg chg="add mod">
          <ac:chgData name="nicolás cecchini" userId="2ee1d923c713d6a4" providerId="LiveId" clId="{BCE686E1-0297-4627-B61C-156CFF4CF7AE}" dt="2020-12-08T14:54:15.427" v="57" actId="164"/>
          <ac:grpSpMkLst>
            <pc:docMk/>
            <pc:sldMk cId="2721414211" sldId="326"/>
            <ac:grpSpMk id="6" creationId="{F276B877-582B-4FD2-9ABD-E8463B63F801}"/>
          </ac:grpSpMkLst>
        </pc:grpChg>
        <pc:graphicFrameChg chg="add mod">
          <ac:chgData name="nicolás cecchini" userId="2ee1d923c713d6a4" providerId="LiveId" clId="{BCE686E1-0297-4627-B61C-156CFF4CF7AE}" dt="2020-12-08T14:54:15.427" v="57" actId="164"/>
          <ac:graphicFrameMkLst>
            <pc:docMk/>
            <pc:sldMk cId="2721414211" sldId="326"/>
            <ac:graphicFrameMk id="22" creationId="{44423487-3157-4063-A083-83C26E77CCC9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https://d.docs.live.net/2ee1d923c713d6a4/Documentos/ongoing_papers/Paper%20traffic-targeting%20AZI1/revision2/figs/extra_data/coloc/Book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905699489049599"/>
          <c:y val="0.126284622852293"/>
          <c:w val="0.74457262498180099"/>
          <c:h val="0.49764039194132298"/>
        </c:manualLayout>
      </c:layout>
      <c:barChart>
        <c:barDir val="col"/>
        <c:grouping val="clustered"/>
        <c:varyColors val="0"/>
        <c:ser>
          <c:idx val="0"/>
          <c:order val="0"/>
          <c:tx>
            <c:v>Series1</c:v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[Book1.xlsx]Sheet1!$L$5:$M$5</c:f>
                <c:numCache>
                  <c:formatCode>General</c:formatCode>
                  <c:ptCount val="2"/>
                  <c:pt idx="0">
                    <c:v>1.4159699848704399</c:v>
                  </c:pt>
                  <c:pt idx="1">
                    <c:v>2.3168290033629981</c:v>
                  </c:pt>
                </c:numCache>
              </c:numRef>
            </c:plus>
            <c:minus>
              <c:numRef>
                <c:f>[Book1.xlsx]Sheet1!$L$5:$M$5</c:f>
                <c:numCache>
                  <c:formatCode>General</c:formatCode>
                  <c:ptCount val="2"/>
                  <c:pt idx="0">
                    <c:v>1.4159699848704399</c:v>
                  </c:pt>
                  <c:pt idx="1">
                    <c:v>2.3168290033629981</c:v>
                  </c:pt>
                </c:numCache>
              </c:numRef>
            </c:minus>
          </c:errBars>
          <c:cat>
            <c:strRef>
              <c:f>[Book1.xlsx]Sheet1!$L$2:$M$2</c:f>
              <c:strCache>
                <c:ptCount val="2"/>
                <c:pt idx="0">
                  <c:v>GFP</c:v>
                </c:pt>
                <c:pt idx="1">
                  <c:v>AZI1:GFP</c:v>
                </c:pt>
              </c:strCache>
            </c:strRef>
          </c:cat>
          <c:val>
            <c:numRef>
              <c:f>[Book1.xlsx]Sheet1!$L$3:$M$3</c:f>
              <c:numCache>
                <c:formatCode>General</c:formatCode>
                <c:ptCount val="2"/>
                <c:pt idx="0">
                  <c:v>3.2763923807747353</c:v>
                </c:pt>
                <c:pt idx="1">
                  <c:v>16.5775299718981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8D-4E3B-BB30-2C9340570D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0"/>
        <c:axId val="19730128"/>
        <c:axId val="19738832"/>
      </c:barChart>
      <c:scatterChart>
        <c:scatterStyle val="lineMarker"/>
        <c:varyColors val="0"/>
        <c:ser>
          <c:idx val="1"/>
          <c:order val="1"/>
          <c:tx>
            <c:v>GFP</c:v>
          </c:tx>
          <c:spPr>
            <a:ln w="19050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xVal>
            <c:numRef>
              <c:f>[Book1.xlsx]Sheet1!$V$9:$V$14</c:f>
              <c:numCache>
                <c:formatCode>General</c:formatCode>
                <c:ptCount val="6"/>
                <c:pt idx="0">
                  <c:v>1.07</c:v>
                </c:pt>
                <c:pt idx="1">
                  <c:v>1.07</c:v>
                </c:pt>
                <c:pt idx="2">
                  <c:v>1.07</c:v>
                </c:pt>
                <c:pt idx="3">
                  <c:v>1.07</c:v>
                </c:pt>
                <c:pt idx="4">
                  <c:v>1.07</c:v>
                </c:pt>
                <c:pt idx="5">
                  <c:v>1.07</c:v>
                </c:pt>
              </c:numCache>
            </c:numRef>
          </c:xVal>
          <c:yVal>
            <c:numRef>
              <c:f>[Book1.xlsx]Sheet1!$U$9:$U$14</c:f>
              <c:numCache>
                <c:formatCode>General</c:formatCode>
                <c:ptCount val="6"/>
                <c:pt idx="0">
                  <c:v>1.1956085015670781</c:v>
                </c:pt>
                <c:pt idx="1">
                  <c:v>7.1105856624504193</c:v>
                </c:pt>
                <c:pt idx="2">
                  <c:v>3.2767268217079035</c:v>
                </c:pt>
                <c:pt idx="3">
                  <c:v>7.8610396625767898</c:v>
                </c:pt>
                <c:pt idx="4">
                  <c:v>0.18413325293909771</c:v>
                </c:pt>
                <c:pt idx="5">
                  <c:v>3.0260383407120423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38D-4E3B-BB30-2C9340570DCE}"/>
            </c:ext>
          </c:extLst>
        </c:ser>
        <c:ser>
          <c:idx val="2"/>
          <c:order val="2"/>
          <c:tx>
            <c:v>AZI1:GFP</c:v>
          </c:tx>
          <c:spPr>
            <a:ln w="19050">
              <a:noFill/>
            </a:ln>
          </c:spPr>
          <c:marker>
            <c:symbol val="circle"/>
            <c:size val="3"/>
            <c:spPr>
              <a:noFill/>
              <a:ln>
                <a:solidFill>
                  <a:schemeClr val="tx1"/>
                </a:solidFill>
              </a:ln>
            </c:spPr>
          </c:marker>
          <c:xVal>
            <c:numRef>
              <c:f>[Book1.xlsx]Sheet1!$V$15:$V$55</c:f>
              <c:numCache>
                <c:formatCode>General</c:formatCode>
                <c:ptCount val="41"/>
                <c:pt idx="0">
                  <c:v>2.0699999999999998</c:v>
                </c:pt>
                <c:pt idx="1">
                  <c:v>2.0699999999999998</c:v>
                </c:pt>
                <c:pt idx="2">
                  <c:v>2.0699999999999998</c:v>
                </c:pt>
                <c:pt idx="3">
                  <c:v>2.0699999999999998</c:v>
                </c:pt>
                <c:pt idx="4">
                  <c:v>2.0699999999999998</c:v>
                </c:pt>
                <c:pt idx="5">
                  <c:v>2.0699999999999998</c:v>
                </c:pt>
                <c:pt idx="6">
                  <c:v>2.0699999999999998</c:v>
                </c:pt>
                <c:pt idx="7">
                  <c:v>2.0699999999999998</c:v>
                </c:pt>
                <c:pt idx="8">
                  <c:v>2.0699999999999998</c:v>
                </c:pt>
                <c:pt idx="9">
                  <c:v>2.0699999999999998</c:v>
                </c:pt>
                <c:pt idx="10">
                  <c:v>2.0699999999999998</c:v>
                </c:pt>
                <c:pt idx="11">
                  <c:v>2.0699999999999998</c:v>
                </c:pt>
                <c:pt idx="12">
                  <c:v>2.0699999999999998</c:v>
                </c:pt>
                <c:pt idx="13">
                  <c:v>2.0699999999999998</c:v>
                </c:pt>
                <c:pt idx="14">
                  <c:v>2.0699999999999998</c:v>
                </c:pt>
                <c:pt idx="15">
                  <c:v>2.0699999999999998</c:v>
                </c:pt>
                <c:pt idx="16">
                  <c:v>2.0699999999999998</c:v>
                </c:pt>
                <c:pt idx="17">
                  <c:v>2.0699999999999998</c:v>
                </c:pt>
                <c:pt idx="18">
                  <c:v>2.0699999999999998</c:v>
                </c:pt>
                <c:pt idx="19">
                  <c:v>2.0699999999999998</c:v>
                </c:pt>
                <c:pt idx="20">
                  <c:v>2.0699999999999998</c:v>
                </c:pt>
                <c:pt idx="21">
                  <c:v>2.0699999999999998</c:v>
                </c:pt>
                <c:pt idx="22">
                  <c:v>2.0699999999999998</c:v>
                </c:pt>
                <c:pt idx="23">
                  <c:v>2.0699999999999998</c:v>
                </c:pt>
                <c:pt idx="24">
                  <c:v>2.0699999999999998</c:v>
                </c:pt>
                <c:pt idx="25">
                  <c:v>2.0699999999999998</c:v>
                </c:pt>
                <c:pt idx="26">
                  <c:v>2.0699999999999998</c:v>
                </c:pt>
                <c:pt idx="27">
                  <c:v>2.0699999999999998</c:v>
                </c:pt>
                <c:pt idx="28">
                  <c:v>2.0699999999999998</c:v>
                </c:pt>
                <c:pt idx="29">
                  <c:v>2.0699999999999998</c:v>
                </c:pt>
                <c:pt idx="30">
                  <c:v>2.0699999999999998</c:v>
                </c:pt>
                <c:pt idx="31">
                  <c:v>2.0699999999999998</c:v>
                </c:pt>
                <c:pt idx="32">
                  <c:v>2.0699999999999998</c:v>
                </c:pt>
                <c:pt idx="33">
                  <c:v>2.0699999999999998</c:v>
                </c:pt>
                <c:pt idx="34">
                  <c:v>2.0699999999999998</c:v>
                </c:pt>
                <c:pt idx="35">
                  <c:v>2.0699999999999998</c:v>
                </c:pt>
                <c:pt idx="36">
                  <c:v>2.0699999999999998</c:v>
                </c:pt>
                <c:pt idx="37">
                  <c:v>2.0699999999999998</c:v>
                </c:pt>
                <c:pt idx="38">
                  <c:v>2.0699999999999998</c:v>
                </c:pt>
                <c:pt idx="39">
                  <c:v>2.0699999999999998</c:v>
                </c:pt>
                <c:pt idx="40">
                  <c:v>2.0699999999999998</c:v>
                </c:pt>
              </c:numCache>
            </c:numRef>
          </c:xVal>
          <c:yVal>
            <c:numRef>
              <c:f>[Book1.xlsx]Sheet1!$U$15:$U$55</c:f>
              <c:numCache>
                <c:formatCode>General</c:formatCode>
                <c:ptCount val="41"/>
                <c:pt idx="0">
                  <c:v>0.60138815549388436</c:v>
                </c:pt>
                <c:pt idx="1">
                  <c:v>9.4956032989790042</c:v>
                </c:pt>
                <c:pt idx="2">
                  <c:v>19.760310444189528</c:v>
                </c:pt>
                <c:pt idx="3">
                  <c:v>4.6687435908433379</c:v>
                </c:pt>
                <c:pt idx="4">
                  <c:v>9.5609788820288006</c:v>
                </c:pt>
                <c:pt idx="5">
                  <c:v>20.47651044867548</c:v>
                </c:pt>
                <c:pt idx="6">
                  <c:v>21.792182294150255</c:v>
                </c:pt>
                <c:pt idx="7">
                  <c:v>14.872837931734006</c:v>
                </c:pt>
                <c:pt idx="8">
                  <c:v>8.9760413050308699E-2</c:v>
                </c:pt>
                <c:pt idx="9">
                  <c:v>4.6122428646989935</c:v>
                </c:pt>
                <c:pt idx="10">
                  <c:v>21.229265902803895</c:v>
                </c:pt>
                <c:pt idx="11">
                  <c:v>15.696101899083581</c:v>
                </c:pt>
                <c:pt idx="12">
                  <c:v>9.3065442984006399</c:v>
                </c:pt>
                <c:pt idx="13">
                  <c:v>1.6526973409994341</c:v>
                </c:pt>
                <c:pt idx="14">
                  <c:v>3.4513062595976791</c:v>
                </c:pt>
                <c:pt idx="15">
                  <c:v>0.88845878869705119</c:v>
                </c:pt>
                <c:pt idx="16">
                  <c:v>5.3117144680680246</c:v>
                </c:pt>
                <c:pt idx="17">
                  <c:v>30.604151343818881</c:v>
                </c:pt>
                <c:pt idx="18">
                  <c:v>1.2506543024677224</c:v>
                </c:pt>
                <c:pt idx="19">
                  <c:v>11.612982470586799</c:v>
                </c:pt>
                <c:pt idx="20">
                  <c:v>1.1189451246753441</c:v>
                </c:pt>
                <c:pt idx="21">
                  <c:v>7.4080301991866424</c:v>
                </c:pt>
                <c:pt idx="22">
                  <c:v>25.14542852844469</c:v>
                </c:pt>
                <c:pt idx="23">
                  <c:v>41.218044263757733</c:v>
                </c:pt>
                <c:pt idx="24">
                  <c:v>10.964910921441787</c:v>
                </c:pt>
                <c:pt idx="25">
                  <c:v>45.035497164100143</c:v>
                </c:pt>
                <c:pt idx="26">
                  <c:v>1.5834351965782916</c:v>
                </c:pt>
                <c:pt idx="27">
                  <c:v>33.574847647859912</c:v>
                </c:pt>
                <c:pt idx="28">
                  <c:v>1.6902916364567213</c:v>
                </c:pt>
                <c:pt idx="29">
                  <c:v>25.454508269198804</c:v>
                </c:pt>
                <c:pt idx="30">
                  <c:v>4.7747977578663567</c:v>
                </c:pt>
                <c:pt idx="31">
                  <c:v>8.3608361354315548</c:v>
                </c:pt>
                <c:pt idx="32">
                  <c:v>2.2101215232199856</c:v>
                </c:pt>
                <c:pt idx="33">
                  <c:v>30.164336380595596</c:v>
                </c:pt>
                <c:pt idx="34">
                  <c:v>31.335940936735803</c:v>
                </c:pt>
                <c:pt idx="35">
                  <c:v>49.894514348133747</c:v>
                </c:pt>
                <c:pt idx="36">
                  <c:v>26.584225354272284</c:v>
                </c:pt>
                <c:pt idx="37">
                  <c:v>5.4352797584972823</c:v>
                </c:pt>
                <c:pt idx="38">
                  <c:v>37.299900310379776</c:v>
                </c:pt>
                <c:pt idx="39">
                  <c:v>37.801643010970331</c:v>
                </c:pt>
                <c:pt idx="40">
                  <c:v>45.6887589816543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38D-4E3B-BB30-2C9340570D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730128"/>
        <c:axId val="19738832"/>
      </c:scatterChart>
      <c:catAx>
        <c:axId val="197301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9738832"/>
        <c:crosses val="autoZero"/>
        <c:auto val="1"/>
        <c:lblAlgn val="ctr"/>
        <c:lblOffset val="25"/>
        <c:noMultiLvlLbl val="0"/>
      </c:catAx>
      <c:valAx>
        <c:axId val="19738832"/>
        <c:scaling>
          <c:orientation val="minMax"/>
          <c:max val="60"/>
          <c:min val="0"/>
        </c:scaling>
        <c:delete val="0"/>
        <c:axPos val="l"/>
        <c:numFmt formatCode="General" sourceLinked="0"/>
        <c:majorTickMark val="out"/>
        <c:minorTickMark val="out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9730128"/>
        <c:crosses val="autoZero"/>
        <c:crossBetween val="between"/>
        <c:majorUnit val="10"/>
      </c:valAx>
      <c:spPr>
        <a:noFill/>
        <a:ln>
          <a:solidFill>
            <a:schemeClr val="tx1"/>
          </a:solidFill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82119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3" y="0"/>
            <a:ext cx="2982119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37AE328-1F8C-4DEE-893D-5F605AA14AEC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33600" y="696913"/>
            <a:ext cx="2614613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15790"/>
            <a:ext cx="550545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7"/>
            <a:ext cx="2982119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3" y="8829967"/>
            <a:ext cx="2982119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7890ECF6-5E24-40CF-BBF0-E3252C9BD69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3818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95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9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8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7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7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6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6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5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83" y="2844804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8" y="2844804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5" indent="0">
              <a:buNone/>
              <a:defRPr sz="2000" b="1"/>
            </a:lvl2pPr>
            <a:lvl3pPr marL="914390" indent="0">
              <a:buNone/>
              <a:defRPr sz="1800" b="1"/>
            </a:lvl3pPr>
            <a:lvl4pPr marL="1371585" indent="0">
              <a:buNone/>
              <a:defRPr sz="1600" b="1"/>
            </a:lvl4pPr>
            <a:lvl5pPr marL="1828778" indent="0">
              <a:buNone/>
              <a:defRPr sz="1600" b="1"/>
            </a:lvl5pPr>
            <a:lvl6pPr marL="2285974" indent="0">
              <a:buNone/>
              <a:defRPr sz="1600" b="1"/>
            </a:lvl6pPr>
            <a:lvl7pPr marL="2743169" indent="0">
              <a:buNone/>
              <a:defRPr sz="1600" b="1"/>
            </a:lvl7pPr>
            <a:lvl8pPr marL="3200363" indent="0">
              <a:buNone/>
              <a:defRPr sz="1600" b="1"/>
            </a:lvl8pPr>
            <a:lvl9pPr marL="365755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7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95" indent="0">
              <a:buNone/>
              <a:defRPr sz="2000" b="1"/>
            </a:lvl2pPr>
            <a:lvl3pPr marL="914390" indent="0">
              <a:buNone/>
              <a:defRPr sz="1800" b="1"/>
            </a:lvl3pPr>
            <a:lvl4pPr marL="1371585" indent="0">
              <a:buNone/>
              <a:defRPr sz="1600" b="1"/>
            </a:lvl4pPr>
            <a:lvl5pPr marL="1828778" indent="0">
              <a:buNone/>
              <a:defRPr sz="1600" b="1"/>
            </a:lvl5pPr>
            <a:lvl6pPr marL="2285974" indent="0">
              <a:buNone/>
              <a:defRPr sz="1600" b="1"/>
            </a:lvl6pPr>
            <a:lvl7pPr marL="2743169" indent="0">
              <a:buNone/>
              <a:defRPr sz="1600" b="1"/>
            </a:lvl7pPr>
            <a:lvl8pPr marL="3200363" indent="0">
              <a:buNone/>
              <a:defRPr sz="1600" b="1"/>
            </a:lvl8pPr>
            <a:lvl9pPr marL="3657558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7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8" y="364070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5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8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95" indent="0">
              <a:buNone/>
              <a:defRPr sz="1200"/>
            </a:lvl2pPr>
            <a:lvl3pPr marL="914390" indent="0">
              <a:buNone/>
              <a:defRPr sz="1000"/>
            </a:lvl3pPr>
            <a:lvl4pPr marL="1371585" indent="0">
              <a:buNone/>
              <a:defRPr sz="900"/>
            </a:lvl4pPr>
            <a:lvl5pPr marL="1828778" indent="0">
              <a:buNone/>
              <a:defRPr sz="900"/>
            </a:lvl5pPr>
            <a:lvl6pPr marL="2285974" indent="0">
              <a:buNone/>
              <a:defRPr sz="900"/>
            </a:lvl6pPr>
            <a:lvl7pPr marL="2743169" indent="0">
              <a:buNone/>
              <a:defRPr sz="900"/>
            </a:lvl7pPr>
            <a:lvl8pPr marL="3200363" indent="0">
              <a:buNone/>
              <a:defRPr sz="900"/>
            </a:lvl8pPr>
            <a:lvl9pPr marL="3657558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4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195" indent="0">
              <a:buNone/>
              <a:defRPr sz="2800"/>
            </a:lvl2pPr>
            <a:lvl3pPr marL="914390" indent="0">
              <a:buNone/>
              <a:defRPr sz="2400"/>
            </a:lvl3pPr>
            <a:lvl4pPr marL="1371585" indent="0">
              <a:buNone/>
              <a:defRPr sz="2000"/>
            </a:lvl4pPr>
            <a:lvl5pPr marL="1828778" indent="0">
              <a:buNone/>
              <a:defRPr sz="2000"/>
            </a:lvl5pPr>
            <a:lvl6pPr marL="2285974" indent="0">
              <a:buNone/>
              <a:defRPr sz="2000"/>
            </a:lvl6pPr>
            <a:lvl7pPr marL="2743169" indent="0">
              <a:buNone/>
              <a:defRPr sz="2000"/>
            </a:lvl7pPr>
            <a:lvl8pPr marL="3200363" indent="0">
              <a:buNone/>
              <a:defRPr sz="2000"/>
            </a:lvl8pPr>
            <a:lvl9pPr marL="3657558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5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95" indent="0">
              <a:buNone/>
              <a:defRPr sz="1200"/>
            </a:lvl2pPr>
            <a:lvl3pPr marL="914390" indent="0">
              <a:buNone/>
              <a:defRPr sz="1000"/>
            </a:lvl3pPr>
            <a:lvl4pPr marL="1371585" indent="0">
              <a:buNone/>
              <a:defRPr sz="900"/>
            </a:lvl4pPr>
            <a:lvl5pPr marL="1828778" indent="0">
              <a:buNone/>
              <a:defRPr sz="900"/>
            </a:lvl5pPr>
            <a:lvl6pPr marL="2285974" indent="0">
              <a:buNone/>
              <a:defRPr sz="900"/>
            </a:lvl6pPr>
            <a:lvl7pPr marL="2743169" indent="0">
              <a:buNone/>
              <a:defRPr sz="900"/>
            </a:lvl7pPr>
            <a:lvl8pPr marL="3200363" indent="0">
              <a:buNone/>
              <a:defRPr sz="900"/>
            </a:lvl8pPr>
            <a:lvl9pPr marL="3657558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70B17D-775C-EC4C-AC02-E3F53CF653CE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70B17D-775C-EC4C-AC02-E3F53CF653CE}" type="datetimeFigureOut">
              <a:rPr lang="en-US" smtClean="0"/>
              <a:pPr/>
              <a:t>1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7F15F2-6782-254F-9429-C87EDB0DAB1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195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6" indent="-342896" algn="l" defTabSz="457195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41" indent="-285746" algn="l" defTabSz="457195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87" indent="-228597" algn="l" defTabSz="457195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81" indent="-228597" algn="l" defTabSz="457195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76" indent="-228597" algn="l" defTabSz="457195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70" indent="-228597" algn="l" defTabSz="457195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66" indent="-228597" algn="l" defTabSz="457195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60" indent="-228597" algn="l" defTabSz="457195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55" indent="-228597" algn="l" defTabSz="457195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95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90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85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78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74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69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63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58" algn="l" defTabSz="457195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467624" y="139690"/>
            <a:ext cx="5835375" cy="215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99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endParaRPr lang="en-US" sz="7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627B5E48-267C-42D9-9405-04CFDA5CF4A0}"/>
              </a:ext>
            </a:extLst>
          </p:cNvPr>
          <p:cNvGrpSpPr/>
          <p:nvPr/>
        </p:nvGrpSpPr>
        <p:grpSpPr>
          <a:xfrm>
            <a:off x="806590" y="2790358"/>
            <a:ext cx="3148830" cy="1214231"/>
            <a:chOff x="806590" y="587209"/>
            <a:chExt cx="3148830" cy="1214231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61D3783-8C08-7544-A19F-F93C61600F3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 rot="5400000" flipH="1" flipV="1">
              <a:off x="1593731" y="207296"/>
              <a:ext cx="475488" cy="1891191"/>
            </a:xfrm>
            <a:prstGeom prst="rect">
              <a:avLst/>
            </a:prstGeom>
            <a:ln w="9525">
              <a:solidFill>
                <a:schemeClr val="tx1"/>
              </a:solidFill>
            </a:ln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84E6CAA-30DE-3D42-BCDD-820A51B4EF3F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 rot="5400000">
              <a:off x="1630306" y="654675"/>
              <a:ext cx="402336" cy="18911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8C938BE8-8BF8-0B43-97D7-EA66BF1012BF}"/>
                </a:ext>
              </a:extLst>
            </p:cNvPr>
            <p:cNvSpPr txBox="1"/>
            <p:nvPr/>
          </p:nvSpPr>
          <p:spPr>
            <a:xfrm>
              <a:off x="806590" y="598397"/>
              <a:ext cx="7429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ZI1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Δ2-25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:GFP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E1A16D42-1C1B-D34D-B7FC-7813DFA9328A}"/>
                </a:ext>
              </a:extLst>
            </p:cNvPr>
            <p:cNvSpPr txBox="1"/>
            <p:nvPr/>
          </p:nvSpPr>
          <p:spPr>
            <a:xfrm>
              <a:off x="940844" y="723898"/>
              <a:ext cx="146700" cy="180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F51CD984-8605-124A-A391-B13C41B80B5D}"/>
                </a:ext>
              </a:extLst>
            </p:cNvPr>
            <p:cNvSpPr txBox="1"/>
            <p:nvPr/>
          </p:nvSpPr>
          <p:spPr>
            <a:xfrm>
              <a:off x="1242904" y="723898"/>
              <a:ext cx="146700" cy="180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724360D3-574D-AC41-96B3-5DD090A46CE3}"/>
                </a:ext>
              </a:extLst>
            </p:cNvPr>
            <p:cNvCxnSpPr>
              <a:cxnSpLocks/>
            </p:cNvCxnSpPr>
            <p:nvPr/>
          </p:nvCxnSpPr>
          <p:spPr>
            <a:xfrm>
              <a:off x="914948" y="755711"/>
              <a:ext cx="5467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F4BB53F6-F6D2-9444-9099-4A53FF0E59A1}"/>
                </a:ext>
              </a:extLst>
            </p:cNvPr>
            <p:cNvSpPr txBox="1"/>
            <p:nvPr/>
          </p:nvSpPr>
          <p:spPr>
            <a:xfrm>
              <a:off x="1470253" y="587209"/>
              <a:ext cx="7429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AZI1</a:t>
              </a:r>
              <a:r>
                <a: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Δ2-30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:GFP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4441F26B-AC0F-2349-B12B-5FF50E787FA0}"/>
                </a:ext>
              </a:extLst>
            </p:cNvPr>
            <p:cNvSpPr txBox="1"/>
            <p:nvPr/>
          </p:nvSpPr>
          <p:spPr>
            <a:xfrm>
              <a:off x="1559814" y="712710"/>
              <a:ext cx="1467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  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30EDBB34-DF33-ED44-9D99-BC8E8D57F655}"/>
                </a:ext>
              </a:extLst>
            </p:cNvPr>
            <p:cNvSpPr txBox="1"/>
            <p:nvPr/>
          </p:nvSpPr>
          <p:spPr>
            <a:xfrm>
              <a:off x="1907210" y="712710"/>
              <a:ext cx="1467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</a:p>
          </p:txBody>
        </p: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783F0E49-7434-9F43-93EF-E83AE986913F}"/>
                </a:ext>
              </a:extLst>
            </p:cNvPr>
            <p:cNvCxnSpPr>
              <a:cxnSpLocks/>
            </p:cNvCxnSpPr>
            <p:nvPr/>
          </p:nvCxnSpPr>
          <p:spPr>
            <a:xfrm>
              <a:off x="1563178" y="748381"/>
              <a:ext cx="5467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8806B554-011A-764C-9E04-02E91E44E3D5}"/>
                </a:ext>
              </a:extLst>
            </p:cNvPr>
            <p:cNvSpPr txBox="1"/>
            <p:nvPr/>
          </p:nvSpPr>
          <p:spPr>
            <a:xfrm>
              <a:off x="2143553" y="595676"/>
              <a:ext cx="5923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86601EC0-D775-0D49-935B-67BC8F652595}"/>
                </a:ext>
              </a:extLst>
            </p:cNvPr>
            <p:cNvSpPr txBox="1"/>
            <p:nvPr/>
          </p:nvSpPr>
          <p:spPr>
            <a:xfrm>
              <a:off x="2175886" y="723661"/>
              <a:ext cx="146700" cy="180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F8273EB1-08F2-C74A-8D62-74A1F41D65DC}"/>
                </a:ext>
              </a:extLst>
            </p:cNvPr>
            <p:cNvSpPr txBox="1"/>
            <p:nvPr/>
          </p:nvSpPr>
          <p:spPr>
            <a:xfrm>
              <a:off x="2477944" y="723661"/>
              <a:ext cx="146700" cy="180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1BE6F336-FCA4-234C-9C92-4838779E86CC}"/>
                </a:ext>
              </a:extLst>
            </p:cNvPr>
            <p:cNvCxnSpPr>
              <a:cxnSpLocks/>
            </p:cNvCxnSpPr>
            <p:nvPr/>
          </p:nvCxnSpPr>
          <p:spPr>
            <a:xfrm>
              <a:off x="2149491" y="754441"/>
              <a:ext cx="546719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63AEAAA-E5FE-4E96-A1FD-2E6AF5839C02}"/>
                </a:ext>
              </a:extLst>
            </p:cNvPr>
            <p:cNvSpPr txBox="1"/>
            <p:nvPr/>
          </p:nvSpPr>
          <p:spPr>
            <a:xfrm>
              <a:off x="2720980" y="1500243"/>
              <a:ext cx="12344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CBB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EE42BB4D-CC2C-41D9-B603-540858438361}"/>
                </a:ext>
              </a:extLst>
            </p:cNvPr>
            <p:cNvSpPr txBox="1"/>
            <p:nvPr/>
          </p:nvSpPr>
          <p:spPr>
            <a:xfrm>
              <a:off x="2720980" y="1025486"/>
              <a:ext cx="71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-yol1/34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19117CD1-B09C-455C-B81C-284C7F9E4A31}"/>
              </a:ext>
            </a:extLst>
          </p:cNvPr>
          <p:cNvSpPr txBox="1"/>
          <p:nvPr/>
        </p:nvSpPr>
        <p:spPr>
          <a:xfrm>
            <a:off x="489274" y="499403"/>
            <a:ext cx="309700" cy="2153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99" dirty="0">
                <a:latin typeface="Arial"/>
                <a:cs typeface="Arial"/>
              </a:rPr>
              <a:t>(a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7B51E78-B3D9-45F9-BE09-F52EC569768A}"/>
              </a:ext>
            </a:extLst>
          </p:cNvPr>
          <p:cNvSpPr txBox="1"/>
          <p:nvPr/>
        </p:nvSpPr>
        <p:spPr>
          <a:xfrm>
            <a:off x="489274" y="2673308"/>
            <a:ext cx="309700" cy="2153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99" dirty="0">
                <a:latin typeface="Arial"/>
                <a:cs typeface="Arial"/>
              </a:rPr>
              <a:t>(b)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F276B877-582B-4FD2-9ABD-E8463B63F801}"/>
              </a:ext>
            </a:extLst>
          </p:cNvPr>
          <p:cNvGrpSpPr/>
          <p:nvPr/>
        </p:nvGrpSpPr>
        <p:grpSpPr>
          <a:xfrm>
            <a:off x="879075" y="521453"/>
            <a:ext cx="1370638" cy="2609850"/>
            <a:chOff x="644125" y="521453"/>
            <a:chExt cx="1370638" cy="2609850"/>
          </a:xfrm>
        </p:grpSpPr>
        <p:graphicFrame>
          <p:nvGraphicFramePr>
            <p:cNvPr id="22" name="Chart 21">
              <a:extLst>
                <a:ext uri="{FF2B5EF4-FFF2-40B4-BE49-F238E27FC236}">
                  <a16:creationId xmlns:a16="http://schemas.microsoft.com/office/drawing/2014/main" id="{44423487-3157-4063-A083-83C26E77CCC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7890383"/>
                </p:ext>
              </p:extLst>
            </p:nvPr>
          </p:nvGraphicFramePr>
          <p:xfrm>
            <a:off x="931853" y="521453"/>
            <a:ext cx="1082910" cy="26098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ADE2E69D-D585-4286-AFF2-21926D147DAA}"/>
                </a:ext>
              </a:extLst>
            </p:cNvPr>
            <p:cNvSpPr/>
            <p:nvPr/>
          </p:nvSpPr>
          <p:spPr>
            <a:xfrm rot="16200000">
              <a:off x="66955" y="1300355"/>
              <a:ext cx="1492637" cy="3382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defRPr sz="1000" b="0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US" sz="799" dirty="0"/>
                <a:t>Colocalized/total</a:t>
              </a:r>
            </a:p>
            <a:p>
              <a:pPr algn="ctr">
                <a:defRPr sz="1000" b="0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US" sz="799" dirty="0"/>
                <a:t> GFP signal (%)</a:t>
              </a:r>
              <a:endParaRPr lang="en-US" sz="79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AC5331DE-02B4-4E76-A2F3-25221782BB4D}"/>
                </a:ext>
              </a:extLst>
            </p:cNvPr>
            <p:cNvSpPr txBox="1"/>
            <p:nvPr/>
          </p:nvSpPr>
          <p:spPr>
            <a:xfrm>
              <a:off x="1242904" y="171865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9DC7E0F-F466-4DA3-9B88-D4D30A9A37B7}"/>
                </a:ext>
              </a:extLst>
            </p:cNvPr>
            <p:cNvSpPr txBox="1"/>
            <p:nvPr/>
          </p:nvSpPr>
          <p:spPr>
            <a:xfrm>
              <a:off x="1670727" y="79078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21414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9601</TotalTime>
  <Words>34</Words>
  <Application>Microsoft Office PowerPoint</Application>
  <PresentationFormat>Letter Paper (8.5x11 in)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Sweet Hom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 Won Jung</dc:creator>
  <cp:lastModifiedBy>nicolás cecchini</cp:lastModifiedBy>
  <cp:revision>3143</cp:revision>
  <cp:lastPrinted>2020-09-23T23:17:58Z</cp:lastPrinted>
  <dcterms:created xsi:type="dcterms:W3CDTF">2014-05-24T06:57:29Z</dcterms:created>
  <dcterms:modified xsi:type="dcterms:W3CDTF">2020-12-09T11:14:51Z</dcterms:modified>
</cp:coreProperties>
</file>